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0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83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ang, Yuyang" userId="624bfbdb-7781-46f6-b49b-a5fb0dad298f" providerId="ADAL" clId="{4557615C-589B-4103-B982-8A7A517690D6}"/>
    <pc:docChg chg="delSld">
      <pc:chgData name="Tang, Yuyang" userId="624bfbdb-7781-46f6-b49b-a5fb0dad298f" providerId="ADAL" clId="{4557615C-589B-4103-B982-8A7A517690D6}" dt="2025-07-28T20:11:53.123" v="0" actId="47"/>
      <pc:docMkLst>
        <pc:docMk/>
      </pc:docMkLst>
      <pc:sldChg chg="del">
        <pc:chgData name="Tang, Yuyang" userId="624bfbdb-7781-46f6-b49b-a5fb0dad298f" providerId="ADAL" clId="{4557615C-589B-4103-B982-8A7A517690D6}" dt="2025-07-28T20:11:53.123" v="0" actId="47"/>
        <pc:sldMkLst>
          <pc:docMk/>
          <pc:sldMk cId="2563217953" sldId="256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A28E89-D934-6523-1600-6B9A53375A3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60D1A7C-F5C1-7D64-47B8-EBFCBE03617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52622C-BCE1-098C-D12A-4E5734C003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406F1-F53B-4442-BCC1-562B9B8206A6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422695-2E3C-56A1-D34E-B23C96B438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FE55CE-D40F-96FE-EEC1-1AC8BE0CEE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A3674-1DB6-4278-9426-11AB3A1F61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5711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32CA62-3414-4C63-B183-7D2488770A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3117656-E9A4-DA54-7BA0-3CB62FF0580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3BC13E-B38C-49F9-2697-0A7A0A918D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406F1-F53B-4442-BCC1-562B9B8206A6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019CE3-2C96-9C66-FDDF-62C0FA6B31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8A3829-BC50-F1F3-9633-6503EE3A77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A3674-1DB6-4278-9426-11AB3A1F61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73706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62CD2CB-D077-1AE7-28F7-F8CA67A1CE0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FC6759B-D051-6671-069A-957BF77CE39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D0D7F0-A358-4446-04FA-CCE9C1ABF2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406F1-F53B-4442-BCC1-562B9B8206A6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1122C8-5FB9-8D2C-9D75-6A4E8D68A3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8E5892-FA6D-25A3-51FE-62E5D40269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A3674-1DB6-4278-9426-11AB3A1F61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13880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FB4097-85B0-FA4D-65AE-EB99675AE8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362AC53-B16A-239B-793E-74C252F129D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8A6CE9-1F41-F291-42AF-D49158A897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406F1-F53B-4442-BCC1-562B9B8206A6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C26175-4999-C908-DEDC-DD8F60E06F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7927B4-9A4A-CC91-3756-4C0A227EAD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A3674-1DB6-4278-9426-11AB3A1F61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6712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17D1A7-E5E2-C0D3-1231-774DCFE29E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60EBAF4-02C3-2B96-C240-64FEE4FC43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48F8AE-0DED-3FB8-3CAE-BAE21AEA47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406F1-F53B-4442-BCC1-562B9B8206A6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2C1CD9-10EE-64A9-B352-2B754FE808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997D9A-9F4E-A828-96A9-F08AAC0063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A3674-1DB6-4278-9426-11AB3A1F61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90894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893B5F-7BC3-1D7C-768C-FFF28E506E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85AAB87-6F1C-C7C6-92C0-F7FC298CB1B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58F58D0-F64A-9624-2F05-87CED90B8B8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3939A87-65CD-743F-86BE-7C93E50DF5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406F1-F53B-4442-BCC1-562B9B8206A6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1829E45-A1D4-C05F-2AFC-FAD95B3E79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5116DAD-4E98-8A8A-18F6-BD22592490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A3674-1DB6-4278-9426-11AB3A1F61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04529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2D5A77-73E4-8C0B-6690-DCA7950761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8049CE9-D277-65A5-96E7-D72305D81AA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BC2C975-1440-2165-3888-EFE60C84B4E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C270E2D-D3A8-BDA2-CCD2-9E7D5173246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9CB4E29-B6AE-B086-DF0C-9739C554FAA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EAC0B65-3754-3927-194A-BF4AD33B91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406F1-F53B-4442-BCC1-562B9B8206A6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BB7C43E-B967-927E-F824-82FB99096E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37BEA22-B935-3B34-151B-35D4F36C20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A3674-1DB6-4278-9426-11AB3A1F61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35225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999737-C49E-1C0C-000C-07A16BE430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D2E8500-FB4A-6057-147F-8E0D7FF19B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406F1-F53B-4442-BCC1-562B9B8206A6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6658AA6-6FE6-ED04-3EA1-64AE29BB4D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7E71D51-BECA-958A-1E52-0B0E27D453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A3674-1DB6-4278-9426-11AB3A1F61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8342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FA5B3FD-9A9F-F882-6660-9FAA932265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406F1-F53B-4442-BCC1-562B9B8206A6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532AFDE-FFFD-91C4-98E9-8370AA5A2C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F60B738-218C-47C3-0E83-D44FDE07BB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A3674-1DB6-4278-9426-11AB3A1F61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84252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2E3F3D-AEF1-7DF7-07E9-EA6B7F3BE9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DA91862-C31E-8AF4-52EB-114836F7F12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BB9B25D-3ABC-EE24-7955-90BBFE4D4A7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BDFADF9-57B1-0F7F-9703-B0CFD9A588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406F1-F53B-4442-BCC1-562B9B8206A6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26A47D4-644F-611C-4377-9B6DB44193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EE0412-8CC6-AD9F-8426-0ABA4E6CC5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A3674-1DB6-4278-9426-11AB3A1F61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90935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EDA1BC-99B3-C371-D482-F3F7914E21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7652337-39D4-D409-DD24-3EB49DEFF7F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D4E6B02-D901-D4D7-004F-216DA051DB1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B83BC12-545C-7284-5ED8-788BBE6319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406F1-F53B-4442-BCC1-562B9B8206A6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82AC5FC-3B63-08C8-E9E8-7A4A160927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32BF497-763E-40D5-F95A-B342A2FD18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A3674-1DB6-4278-9426-11AB3A1F61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62841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390F0AB-CC75-441E-8E20-1AAA16CEAF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E2E79A2-25AD-8D57-01B9-3D46C6C338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4D7B9A-B60E-BE64-49E9-C9FE049DCD0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37406F1-F53B-4442-BCC1-562B9B8206A6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77CF67-94A1-5F81-0814-89ACCBB79A3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056DF46-F2AE-E07F-46B1-8AE75416F0D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DAA3674-1DB6-4278-9426-11AB3A1F61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7733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562D449B-5B4E-E94B-E3F5-1D653EFE4291}"/>
              </a:ext>
            </a:extLst>
          </p:cNvPr>
          <p:cNvGrpSpPr/>
          <p:nvPr/>
        </p:nvGrpSpPr>
        <p:grpSpPr>
          <a:xfrm>
            <a:off x="5782723" y="-92223"/>
            <a:ext cx="2903280" cy="2382134"/>
            <a:chOff x="5789650" y="-92223"/>
            <a:chExt cx="2903280" cy="2382134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0636482A-07D5-DD47-3991-C1930309A94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789650" y="0"/>
              <a:ext cx="2903280" cy="2289911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94AA99E5-FB9B-AD1C-E6C7-492EFFAE1788}"/>
                </a:ext>
              </a:extLst>
            </p:cNvPr>
            <p:cNvSpPr txBox="1"/>
            <p:nvPr/>
          </p:nvSpPr>
          <p:spPr>
            <a:xfrm>
              <a:off x="6709536" y="-92223"/>
              <a:ext cx="1063507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dirty="0"/>
                <a:t>Neurons</a:t>
              </a:r>
            </a:p>
          </p:txBody>
        </p:sp>
      </p:grpSp>
      <p:pic>
        <p:nvPicPr>
          <p:cNvPr id="11" name="Picture 10">
            <a:extLst>
              <a:ext uri="{FF2B5EF4-FFF2-40B4-BE49-F238E27FC236}">
                <a16:creationId xmlns:a16="http://schemas.microsoft.com/office/drawing/2014/main" id="{BF3F13B0-6B99-18D5-2035-C1D4D3AC05B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16912" y="0"/>
            <a:ext cx="2903280" cy="2289911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297C466F-7950-4863-A019-6ACC3B19AF4C}"/>
              </a:ext>
            </a:extLst>
          </p:cNvPr>
          <p:cNvSpPr txBox="1"/>
          <p:nvPr/>
        </p:nvSpPr>
        <p:spPr>
          <a:xfrm>
            <a:off x="751061" y="-92223"/>
            <a:ext cx="113867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dirty="0"/>
              <a:t>Microglia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7807A833-9BB0-5B9A-55DF-D2649D27E96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2393049"/>
            <a:ext cx="2903280" cy="2289911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0B08F6C6-5537-6CBC-616D-20AA7ADB1CC2}"/>
              </a:ext>
            </a:extLst>
          </p:cNvPr>
          <p:cNvSpPr txBox="1"/>
          <p:nvPr/>
        </p:nvSpPr>
        <p:spPr>
          <a:xfrm>
            <a:off x="778716" y="2319725"/>
            <a:ext cx="134043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Pericytes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32E15253-AABE-9B3A-99BB-69CB51D5401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954509" y="0"/>
            <a:ext cx="2811350" cy="2217403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0CB30CAB-424C-23ED-1D22-54D79084A868}"/>
              </a:ext>
            </a:extLst>
          </p:cNvPr>
          <p:cNvSpPr txBox="1"/>
          <p:nvPr/>
        </p:nvSpPr>
        <p:spPr>
          <a:xfrm>
            <a:off x="3584195" y="-92223"/>
            <a:ext cx="149032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Macrophage</a:t>
            </a:r>
          </a:p>
        </p:txBody>
      </p:sp>
      <p:pic>
        <p:nvPicPr>
          <p:cNvPr id="23" name="Picture 22">
            <a:extLst>
              <a:ext uri="{FF2B5EF4-FFF2-40B4-BE49-F238E27FC236}">
                <a16:creationId xmlns:a16="http://schemas.microsoft.com/office/drawing/2014/main" id="{40487D11-AE38-B052-9428-5C0BE6E8014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686003" y="2465094"/>
            <a:ext cx="2544839" cy="2007197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CED15B11-D2B2-ECFD-B7B1-058A224B1CAC}"/>
              </a:ext>
            </a:extLst>
          </p:cNvPr>
          <p:cNvSpPr txBox="1"/>
          <p:nvPr/>
        </p:nvSpPr>
        <p:spPr>
          <a:xfrm>
            <a:off x="9516285" y="2217403"/>
            <a:ext cx="149032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T cells</a:t>
            </a: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67C7A87E-FE77-86C6-BD2C-D17F8AB1418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1897" y="4720422"/>
            <a:ext cx="2458600" cy="1939177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F73766C2-D8AD-12CB-52D0-53E2AE2B6790}"/>
              </a:ext>
            </a:extLst>
          </p:cNvPr>
          <p:cNvSpPr txBox="1"/>
          <p:nvPr/>
        </p:nvSpPr>
        <p:spPr>
          <a:xfrm>
            <a:off x="737894" y="4682960"/>
            <a:ext cx="167999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dirty="0"/>
              <a:t>Epithelial Cells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C2E4F61-ED71-4080-62F0-FBFF3F76FE69}"/>
              </a:ext>
            </a:extLst>
          </p:cNvPr>
          <p:cNvSpPr txBox="1"/>
          <p:nvPr/>
        </p:nvSpPr>
        <p:spPr>
          <a:xfrm>
            <a:off x="11594872" y="6439501"/>
            <a:ext cx="70986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dirty="0">
                <a:solidFill>
                  <a:srgbClr val="FF0000"/>
                </a:solidFill>
              </a:rPr>
              <a:t>N7</a:t>
            </a:r>
          </a:p>
        </p:txBody>
      </p:sp>
      <p:sp>
        <p:nvSpPr>
          <p:cNvPr id="32" name="Rectangle: Rounded Corners 31">
            <a:extLst>
              <a:ext uri="{FF2B5EF4-FFF2-40B4-BE49-F238E27FC236}">
                <a16:creationId xmlns:a16="http://schemas.microsoft.com/office/drawing/2014/main" id="{247CFFD5-1F40-9A1B-2788-359B196D5E3D}"/>
              </a:ext>
            </a:extLst>
          </p:cNvPr>
          <p:cNvSpPr/>
          <p:nvPr/>
        </p:nvSpPr>
        <p:spPr>
          <a:xfrm>
            <a:off x="3035384" y="1210529"/>
            <a:ext cx="1872885" cy="159219"/>
          </a:xfrm>
          <a:prstGeom prst="roundRect">
            <a:avLst/>
          </a:prstGeom>
          <a:noFill/>
          <a:ln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Rectangle: Rounded Corners 32">
            <a:extLst>
              <a:ext uri="{FF2B5EF4-FFF2-40B4-BE49-F238E27FC236}">
                <a16:creationId xmlns:a16="http://schemas.microsoft.com/office/drawing/2014/main" id="{140E6FC4-811B-B526-C217-99404B10F3D6}"/>
              </a:ext>
            </a:extLst>
          </p:cNvPr>
          <p:cNvSpPr/>
          <p:nvPr/>
        </p:nvSpPr>
        <p:spPr>
          <a:xfrm>
            <a:off x="51688" y="728787"/>
            <a:ext cx="2336123" cy="158328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Rectangle: Rounded Corners 33">
            <a:extLst>
              <a:ext uri="{FF2B5EF4-FFF2-40B4-BE49-F238E27FC236}">
                <a16:creationId xmlns:a16="http://schemas.microsoft.com/office/drawing/2014/main" id="{92AABD34-E630-FB04-35BE-B859B92C49A5}"/>
              </a:ext>
            </a:extLst>
          </p:cNvPr>
          <p:cNvSpPr/>
          <p:nvPr/>
        </p:nvSpPr>
        <p:spPr>
          <a:xfrm>
            <a:off x="43215" y="1556290"/>
            <a:ext cx="2336123" cy="189969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Rectangle: Rounded Corners 34">
            <a:extLst>
              <a:ext uri="{FF2B5EF4-FFF2-40B4-BE49-F238E27FC236}">
                <a16:creationId xmlns:a16="http://schemas.microsoft.com/office/drawing/2014/main" id="{827FEE0C-8648-3C17-C815-A6E29C974F8F}"/>
              </a:ext>
            </a:extLst>
          </p:cNvPr>
          <p:cNvSpPr/>
          <p:nvPr/>
        </p:nvSpPr>
        <p:spPr>
          <a:xfrm>
            <a:off x="43214" y="1765673"/>
            <a:ext cx="2336123" cy="152507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Rectangle: Rounded Corners 35">
            <a:extLst>
              <a:ext uri="{FF2B5EF4-FFF2-40B4-BE49-F238E27FC236}">
                <a16:creationId xmlns:a16="http://schemas.microsoft.com/office/drawing/2014/main" id="{80C1E045-A281-94C8-CDC8-0BA738C4B92C}"/>
              </a:ext>
            </a:extLst>
          </p:cNvPr>
          <p:cNvSpPr/>
          <p:nvPr/>
        </p:nvSpPr>
        <p:spPr>
          <a:xfrm>
            <a:off x="55245" y="549567"/>
            <a:ext cx="2336123" cy="158328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Rectangle: Rounded Corners 36">
            <a:extLst>
              <a:ext uri="{FF2B5EF4-FFF2-40B4-BE49-F238E27FC236}">
                <a16:creationId xmlns:a16="http://schemas.microsoft.com/office/drawing/2014/main" id="{6F77BC50-B9D0-4C69-1ED2-561DB207DCD6}"/>
              </a:ext>
            </a:extLst>
          </p:cNvPr>
          <p:cNvSpPr/>
          <p:nvPr/>
        </p:nvSpPr>
        <p:spPr>
          <a:xfrm>
            <a:off x="51229" y="365080"/>
            <a:ext cx="2336123" cy="158328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Rectangle: Rounded Corners 37">
            <a:extLst>
              <a:ext uri="{FF2B5EF4-FFF2-40B4-BE49-F238E27FC236}">
                <a16:creationId xmlns:a16="http://schemas.microsoft.com/office/drawing/2014/main" id="{8D90B7D3-8223-5CE6-5688-E3D17140FC48}"/>
              </a:ext>
            </a:extLst>
          </p:cNvPr>
          <p:cNvSpPr/>
          <p:nvPr/>
        </p:nvSpPr>
        <p:spPr>
          <a:xfrm>
            <a:off x="53234" y="204659"/>
            <a:ext cx="2336123" cy="158328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Rectangle: Rounded Corners 39">
            <a:extLst>
              <a:ext uri="{FF2B5EF4-FFF2-40B4-BE49-F238E27FC236}">
                <a16:creationId xmlns:a16="http://schemas.microsoft.com/office/drawing/2014/main" id="{A2C6C8E6-F355-CD50-06E3-092E68DC8104}"/>
              </a:ext>
            </a:extLst>
          </p:cNvPr>
          <p:cNvSpPr/>
          <p:nvPr/>
        </p:nvSpPr>
        <p:spPr>
          <a:xfrm>
            <a:off x="51230" y="1407900"/>
            <a:ext cx="2328108" cy="152508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108713A5-B964-3DF5-09CF-59C7C71381A6}"/>
              </a:ext>
            </a:extLst>
          </p:cNvPr>
          <p:cNvGrpSpPr/>
          <p:nvPr/>
        </p:nvGrpSpPr>
        <p:grpSpPr>
          <a:xfrm>
            <a:off x="5888955" y="2166166"/>
            <a:ext cx="2517887" cy="2285987"/>
            <a:chOff x="6003052" y="2406784"/>
            <a:chExt cx="2517887" cy="2285987"/>
          </a:xfrm>
        </p:grpSpPr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FA11004E-9549-0BD9-FAE5-9F67A7ED8459}"/>
                </a:ext>
              </a:extLst>
            </p:cNvPr>
            <p:cNvSpPr txBox="1"/>
            <p:nvPr/>
          </p:nvSpPr>
          <p:spPr>
            <a:xfrm>
              <a:off x="6578247" y="2406784"/>
              <a:ext cx="1938787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dirty="0"/>
                <a:t>Endothelial Cells</a:t>
              </a:r>
            </a:p>
          </p:txBody>
        </p:sp>
        <p:pic>
          <p:nvPicPr>
            <p:cNvPr id="42" name="Picture 41">
              <a:extLst>
                <a:ext uri="{FF2B5EF4-FFF2-40B4-BE49-F238E27FC236}">
                  <a16:creationId xmlns:a16="http://schemas.microsoft.com/office/drawing/2014/main" id="{014D40F1-4221-90CB-EE2C-5A5209BAEE13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6003052" y="2705713"/>
              <a:ext cx="2517887" cy="1987058"/>
            </a:xfrm>
            <a:prstGeom prst="rect">
              <a:avLst/>
            </a:prstGeom>
          </p:spPr>
        </p:pic>
      </p:grpSp>
      <p:pic>
        <p:nvPicPr>
          <p:cNvPr id="15" name="Picture 14">
            <a:extLst>
              <a:ext uri="{FF2B5EF4-FFF2-40B4-BE49-F238E27FC236}">
                <a16:creationId xmlns:a16="http://schemas.microsoft.com/office/drawing/2014/main" id="{942BCF04-822D-65C4-F365-6E2E6100E1B3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933453" y="2222968"/>
            <a:ext cx="2903281" cy="2288622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1FAAE6F5-704C-DE7B-BEDE-F694D032F676}"/>
              </a:ext>
            </a:extLst>
          </p:cNvPr>
          <p:cNvSpPr txBox="1"/>
          <p:nvPr/>
        </p:nvSpPr>
        <p:spPr>
          <a:xfrm>
            <a:off x="3428780" y="2164424"/>
            <a:ext cx="203978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dirty="0"/>
              <a:t>Oligodendrocytes</a:t>
            </a:r>
          </a:p>
        </p:txBody>
      </p:sp>
      <p:sp>
        <p:nvSpPr>
          <p:cNvPr id="19" name="Rectangle: Rounded Corners 18">
            <a:extLst>
              <a:ext uri="{FF2B5EF4-FFF2-40B4-BE49-F238E27FC236}">
                <a16:creationId xmlns:a16="http://schemas.microsoft.com/office/drawing/2014/main" id="{7373B21F-F569-CC45-154A-E189846B2A9F}"/>
              </a:ext>
            </a:extLst>
          </p:cNvPr>
          <p:cNvSpPr/>
          <p:nvPr/>
        </p:nvSpPr>
        <p:spPr>
          <a:xfrm>
            <a:off x="68903" y="1092703"/>
            <a:ext cx="2309344" cy="142721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: Rounded Corners 25">
            <a:extLst>
              <a:ext uri="{FF2B5EF4-FFF2-40B4-BE49-F238E27FC236}">
                <a16:creationId xmlns:a16="http://schemas.microsoft.com/office/drawing/2014/main" id="{CD2B77FC-0B3B-CA22-9130-EF8076CFE395}"/>
              </a:ext>
            </a:extLst>
          </p:cNvPr>
          <p:cNvSpPr/>
          <p:nvPr/>
        </p:nvSpPr>
        <p:spPr>
          <a:xfrm>
            <a:off x="57067" y="907254"/>
            <a:ext cx="2328107" cy="159263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0F8617A0-C70B-082D-8912-362ED62DC621}"/>
              </a:ext>
            </a:extLst>
          </p:cNvPr>
          <p:cNvGrpSpPr/>
          <p:nvPr/>
        </p:nvGrpSpPr>
        <p:grpSpPr>
          <a:xfrm>
            <a:off x="8810626" y="-75580"/>
            <a:ext cx="2901646" cy="2347167"/>
            <a:chOff x="8810626" y="2362825"/>
            <a:chExt cx="2901646" cy="2347167"/>
          </a:xfrm>
        </p:grpSpPr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ACC21A67-BC40-073C-DD3B-BDFAB51A49D9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8810626" y="2421370"/>
              <a:ext cx="2901646" cy="2288622"/>
            </a:xfrm>
            <a:prstGeom prst="rect">
              <a:avLst/>
            </a:prstGeom>
          </p:spPr>
        </p:pic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5A82CA17-12DA-055A-264F-3BB1715A9F05}"/>
                </a:ext>
              </a:extLst>
            </p:cNvPr>
            <p:cNvSpPr txBox="1"/>
            <p:nvPr/>
          </p:nvSpPr>
          <p:spPr>
            <a:xfrm>
              <a:off x="9292055" y="2362825"/>
              <a:ext cx="1938787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dirty="0"/>
                <a:t>Astrocytes</a:t>
              </a:r>
            </a:p>
          </p:txBody>
        </p:sp>
      </p:grpSp>
      <p:pic>
        <p:nvPicPr>
          <p:cNvPr id="2" name="Picture 1">
            <a:extLst>
              <a:ext uri="{FF2B5EF4-FFF2-40B4-BE49-F238E27FC236}">
                <a16:creationId xmlns:a16="http://schemas.microsoft.com/office/drawing/2014/main" id="{7418812B-985B-6EBF-B30C-24F50E3EFA43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117490" y="4568090"/>
            <a:ext cx="6594781" cy="2316785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A0E3BB51-D921-C7E0-FC39-D9565AA7C7F2}"/>
              </a:ext>
            </a:extLst>
          </p:cNvPr>
          <p:cNvSpPr txBox="1"/>
          <p:nvPr/>
        </p:nvSpPr>
        <p:spPr>
          <a:xfrm>
            <a:off x="-84642" y="6587933"/>
            <a:ext cx="455966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7 Fig. Related to Figure 7</a:t>
            </a:r>
          </a:p>
          <a:p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E009EC59-522E-DA4B-9970-74C5198BFE0E}"/>
              </a:ext>
            </a:extLst>
          </p:cNvPr>
          <p:cNvSpPr txBox="1"/>
          <p:nvPr/>
        </p:nvSpPr>
        <p:spPr>
          <a:xfrm>
            <a:off x="-82805" y="-107678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E8E5FEEE-A0D5-179E-4FDB-31CED3268B52}"/>
              </a:ext>
            </a:extLst>
          </p:cNvPr>
          <p:cNvSpPr txBox="1"/>
          <p:nvPr/>
        </p:nvSpPr>
        <p:spPr>
          <a:xfrm>
            <a:off x="4896231" y="4540600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4865881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2</Words>
  <Application>Microsoft Office PowerPoint</Application>
  <PresentationFormat>Widescreen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ang, Yuyang</dc:creator>
  <cp:lastModifiedBy>Tang, Yuyang</cp:lastModifiedBy>
  <cp:revision>1</cp:revision>
  <dcterms:created xsi:type="dcterms:W3CDTF">2025-07-28T20:11:22Z</dcterms:created>
  <dcterms:modified xsi:type="dcterms:W3CDTF">2025-07-28T20:11:54Z</dcterms:modified>
</cp:coreProperties>
</file>